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1"/>
  </p:notesMasterIdLst>
  <p:sldIdLst>
    <p:sldId id="306" r:id="rId5"/>
    <p:sldId id="309" r:id="rId6"/>
    <p:sldId id="310" r:id="rId7"/>
    <p:sldId id="307" r:id="rId8"/>
    <p:sldId id="308" r:id="rId9"/>
    <p:sldId id="311" r:id="rId10"/>
  </p:sldIdLst>
  <p:sldSz cx="9906000" cy="6858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ACB09F0-EEFE-4F6C-B523-B0F2F52A23F1}">
          <p14:sldIdLst>
            <p14:sldId id="306"/>
            <p14:sldId id="309"/>
            <p14:sldId id="310"/>
            <p14:sldId id="307"/>
            <p14:sldId id="308"/>
            <p14:sldId id="31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08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 Anjomani-Virmouni (Staff)" initials="SA(" lastIdx="2" clrIdx="0">
    <p:extLst>
      <p:ext uri="{19B8F6BF-5375-455C-9EA6-DF929625EA0E}">
        <p15:presenceInfo xmlns:p15="http://schemas.microsoft.com/office/powerpoint/2012/main" userId="S-1-5-21-1614895754-484763869-682003330-1735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42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504" y="48"/>
      </p:cViewPr>
      <p:guideLst>
        <p:guide orient="horz" pos="2160"/>
        <p:guide pos="30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C19FC5-5E47-4214-9B31-8FD56EA0BC05}" type="datetimeFigureOut">
              <a:rPr lang="en-GB" smtClean="0"/>
              <a:t>30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308350" y="850900"/>
            <a:ext cx="3309938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201" y="3271103"/>
            <a:ext cx="7942238" cy="267645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1696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137582-23D2-4D39-9885-1A92A9AF6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56593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4968-5853-4FEE-85C1-74BEA6013EEF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6375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8D4B4-4990-4275-8E98-077C471D0036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4671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0B30E-351F-433E-8CAC-8F7C176AE74A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747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870A0-74DC-471E-A040-392E92C29537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3553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B55E6-A110-4DAE-B048-10EDCBDD03F1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60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9FB22-9CFD-4344-AE66-418B0F5FD183}" type="datetime1">
              <a:rPr lang="en-GB" smtClean="0"/>
              <a:t>3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295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4EA8D-0D82-421A-82C1-4FF3BE433CC3}" type="datetime1">
              <a:rPr lang="en-GB" smtClean="0"/>
              <a:t>30/07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007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91F70-F315-4395-96D4-013AF483D011}" type="datetime1">
              <a:rPr lang="en-GB" smtClean="0"/>
              <a:t>30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3847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0FB00-4ADB-4A1A-A08E-85C53B362E28}" type="datetime1">
              <a:rPr lang="en-GB" smtClean="0"/>
              <a:t>30/07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56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8FC1E-22C9-4D19-8606-1478385E7786}" type="datetime1">
              <a:rPr lang="en-GB" smtClean="0"/>
              <a:t>3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003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7BA14-9B28-490F-A95D-4D44C9B71E63}" type="datetime1">
              <a:rPr lang="en-GB" smtClean="0"/>
              <a:t>30/07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112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2809F-B7F2-4540-9E44-7EEC1A07F360}" type="datetime1">
              <a:rPr lang="en-GB" smtClean="0"/>
              <a:t>30/07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2244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214B75B-36F8-4C59-8F3D-8DB9E2F42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1</a:t>
            </a:fld>
            <a:endParaRPr lang="en-GB"/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D17A407-5BC5-45D7-A23A-6414043890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0027762"/>
              </p:ext>
            </p:extLst>
          </p:nvPr>
        </p:nvGraphicFramePr>
        <p:xfrm>
          <a:off x="174291" y="774215"/>
          <a:ext cx="9597825" cy="43256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9" name="Worksheet" r:id="rId3" imgW="10655177" imgH="4800600" progId="Excel.Sheet.12">
                  <p:embed/>
                </p:oleObj>
              </mc:Choice>
              <mc:Fallback>
                <p:oleObj name="Worksheet" r:id="rId3" imgW="10655177" imgH="48006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4291" y="774215"/>
                        <a:ext cx="9597825" cy="432568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6E7F2B80-C3CD-4CF6-9D1F-7FF914C02424}"/>
              </a:ext>
            </a:extLst>
          </p:cNvPr>
          <p:cNvSpPr txBox="1">
            <a:spLocks/>
          </p:cNvSpPr>
          <p:nvPr/>
        </p:nvSpPr>
        <p:spPr>
          <a:xfrm>
            <a:off x="-3332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1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ght, Rotarod and Beam-walk analyses of YG8JR FRDA and Y47JR control mice.</a:t>
            </a:r>
          </a:p>
        </p:txBody>
      </p:sp>
    </p:spTree>
    <p:extLst>
      <p:ext uri="{BB962C8B-B14F-4D97-AF65-F5344CB8AC3E}">
        <p14:creationId xmlns:p14="http://schemas.microsoft.com/office/powerpoint/2010/main" val="2442802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43941F6-296A-4CE8-9FEE-ED3C04A51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2</a:t>
            </a:fld>
            <a:endParaRPr lang="en-GB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6AEA159-85F4-4B4C-BA9C-0A529A8C22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749128"/>
              </p:ext>
            </p:extLst>
          </p:nvPr>
        </p:nvGraphicFramePr>
        <p:xfrm>
          <a:off x="169682" y="799192"/>
          <a:ext cx="9615341" cy="3161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8" name="Worksheet" r:id="rId3" imgW="14922377" imgH="4908425" progId="Excel.Sheet.12">
                  <p:embed/>
                </p:oleObj>
              </mc:Choice>
              <mc:Fallback>
                <p:oleObj name="Worksheet" r:id="rId3" imgW="14922377" imgH="4908425" progId="Excel.Sheet.12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55B85F4-DBDE-4290-9753-BFD05800E6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9682" y="799192"/>
                        <a:ext cx="9615341" cy="316171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itle 1">
            <a:extLst>
              <a:ext uri="{FF2B5EF4-FFF2-40B4-BE49-F238E27FC236}">
                <a16:creationId xmlns:a16="http://schemas.microsoft.com/office/drawing/2014/main" id="{21BB58D5-9B70-4B30-95DB-5B028400C870}"/>
              </a:ext>
            </a:extLst>
          </p:cNvPr>
          <p:cNvSpPr txBox="1">
            <a:spLocks/>
          </p:cNvSpPr>
          <p:nvPr/>
        </p:nvSpPr>
        <p:spPr>
          <a:xfrm>
            <a:off x="-3600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2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Ambulatory distance in YG8JR FRDA and Y47JR control mice.</a:t>
            </a:r>
          </a:p>
        </p:txBody>
      </p:sp>
    </p:spTree>
    <p:extLst>
      <p:ext uri="{BB962C8B-B14F-4D97-AF65-F5344CB8AC3E}">
        <p14:creationId xmlns:p14="http://schemas.microsoft.com/office/powerpoint/2010/main" val="525166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D06695DB-9C9A-4729-9A43-3B99D05BD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3</a:t>
            </a:fld>
            <a:endParaRPr lang="en-GB"/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71EF773C-5003-47AB-9613-47BF04D284B2}"/>
              </a:ext>
            </a:extLst>
          </p:cNvPr>
          <p:cNvSpPr txBox="1">
            <a:spLocks/>
          </p:cNvSpPr>
          <p:nvPr/>
        </p:nvSpPr>
        <p:spPr>
          <a:xfrm>
            <a:off x="-3600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3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Vertical time in YG8JR FRDA and Y47JR control mice.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19254B6-7528-489D-B9C3-F6A8B205DA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5330246"/>
              </p:ext>
            </p:extLst>
          </p:nvPr>
        </p:nvGraphicFramePr>
        <p:xfrm>
          <a:off x="168619" y="774000"/>
          <a:ext cx="9644684" cy="30742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0" name="Worksheet" r:id="rId3" imgW="14922377" imgH="4756201" progId="Excel.Sheet.12">
                  <p:embed/>
                </p:oleObj>
              </mc:Choice>
              <mc:Fallback>
                <p:oleObj name="Worksheet" r:id="rId3" imgW="14922377" imgH="4756201" progId="Excel.Shee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0A36423-830B-4EB0-A0F4-AAB9DFA73A4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619" y="774000"/>
                        <a:ext cx="9644684" cy="307424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526885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1BA2F60-9986-4B9C-9D37-7A8E4FA11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4</a:t>
            </a:fld>
            <a:endParaRPr lang="en-GB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4D5ADC3-F57F-4D8C-9CE6-70BF7EE937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0435877"/>
              </p:ext>
            </p:extLst>
          </p:nvPr>
        </p:nvGraphicFramePr>
        <p:xfrm>
          <a:off x="174415" y="774000"/>
          <a:ext cx="9638888" cy="3068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1" name="Worksheet" r:id="rId3" imgW="14922377" imgH="4749859" progId="Excel.Sheet.12">
                  <p:embed/>
                </p:oleObj>
              </mc:Choice>
              <mc:Fallback>
                <p:oleObj name="Worksheet" r:id="rId3" imgW="14922377" imgH="4749859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4415" y="774000"/>
                        <a:ext cx="9638888" cy="306873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B09EBF7A-63CF-4350-86FA-9F7A8772B6E8}"/>
              </a:ext>
            </a:extLst>
          </p:cNvPr>
          <p:cNvSpPr txBox="1">
            <a:spLocks/>
          </p:cNvSpPr>
          <p:nvPr/>
        </p:nvSpPr>
        <p:spPr>
          <a:xfrm>
            <a:off x="-3600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4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Vertical count in YG8JR FRDA and Y47JR control mice.</a:t>
            </a:r>
          </a:p>
        </p:txBody>
      </p:sp>
    </p:spTree>
    <p:extLst>
      <p:ext uri="{BB962C8B-B14F-4D97-AF65-F5344CB8AC3E}">
        <p14:creationId xmlns:p14="http://schemas.microsoft.com/office/powerpoint/2010/main" val="12294853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1577445-CCC0-4D4B-8A68-EED35898D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5</a:t>
            </a:fld>
            <a:endParaRPr lang="en-GB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E986023-9E12-42B1-A99E-DAEFD14708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4922288"/>
              </p:ext>
            </p:extLst>
          </p:nvPr>
        </p:nvGraphicFramePr>
        <p:xfrm>
          <a:off x="175605" y="782424"/>
          <a:ext cx="9645645" cy="3081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5" name="Worksheet" r:id="rId3" imgW="14922377" imgH="4768887" progId="Excel.Sheet.12">
                  <p:embed/>
                </p:oleObj>
              </mc:Choice>
              <mc:Fallback>
                <p:oleObj name="Worksheet" r:id="rId3" imgW="14922377" imgH="4768887" progId="Excel.Sheet.12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20E482F-3816-4CA2-8139-0A15647B25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5605" y="782424"/>
                        <a:ext cx="9645645" cy="3081249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FA849CEB-BFD3-42C9-A650-814E722D8936}"/>
              </a:ext>
            </a:extLst>
          </p:cNvPr>
          <p:cNvSpPr txBox="1">
            <a:spLocks/>
          </p:cNvSpPr>
          <p:nvPr/>
        </p:nvSpPr>
        <p:spPr>
          <a:xfrm>
            <a:off x="-3600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5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Jump count in YG8JR FRDA and Y47JR control mice.</a:t>
            </a:r>
          </a:p>
        </p:txBody>
      </p:sp>
    </p:spTree>
    <p:extLst>
      <p:ext uri="{BB962C8B-B14F-4D97-AF65-F5344CB8AC3E}">
        <p14:creationId xmlns:p14="http://schemas.microsoft.com/office/powerpoint/2010/main" val="24443124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1577445-CCC0-4D4B-8A68-EED35898D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6</a:t>
            </a:fld>
            <a:endParaRPr lang="en-GB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D9DD9BD-FBC9-46C3-ABEC-868EFF95B7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571414"/>
              </p:ext>
            </p:extLst>
          </p:nvPr>
        </p:nvGraphicFramePr>
        <p:xfrm>
          <a:off x="158717" y="772998"/>
          <a:ext cx="9674839" cy="30435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4" name="Worksheet" r:id="rId3" imgW="14922377" imgH="4692775" progId="Excel.Sheet.12">
                  <p:embed/>
                </p:oleObj>
              </mc:Choice>
              <mc:Fallback>
                <p:oleObj name="Worksheet" r:id="rId3" imgW="14922377" imgH="4692775" progId="Excel.Shee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D9DD9BD-FBC9-46C3-ABEC-868EFF95B7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717" y="772998"/>
                        <a:ext cx="9674839" cy="304354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FA849CEB-BFD3-42C9-A650-814E722D8936}"/>
              </a:ext>
            </a:extLst>
          </p:cNvPr>
          <p:cNvSpPr txBox="1">
            <a:spLocks/>
          </p:cNvSpPr>
          <p:nvPr/>
        </p:nvSpPr>
        <p:spPr>
          <a:xfrm>
            <a:off x="-3600" y="360626"/>
            <a:ext cx="4687143" cy="827179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83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able S6. </a:t>
            </a:r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Average velocity in YG8JR FRDA and Y47JR control mice.</a:t>
            </a:r>
          </a:p>
        </p:txBody>
      </p:sp>
    </p:spTree>
    <p:extLst>
      <p:ext uri="{BB962C8B-B14F-4D97-AF65-F5344CB8AC3E}">
        <p14:creationId xmlns:p14="http://schemas.microsoft.com/office/powerpoint/2010/main" val="3088577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0C26ED90A69A419BABE0D82A2EDDEE" ma:contentTypeVersion="13" ma:contentTypeDescription="Create a new document." ma:contentTypeScope="" ma:versionID="b898098913977cba560e38dda6c2c2d8">
  <xsd:schema xmlns:xsd="http://www.w3.org/2001/XMLSchema" xmlns:xs="http://www.w3.org/2001/XMLSchema" xmlns:p="http://schemas.microsoft.com/office/2006/metadata/properties" xmlns:ns3="6b1eb8ff-d135-439f-bb7f-2053783ee46f" xmlns:ns4="5a9be704-24a8-48cf-a95f-6bbabe7e0097" targetNamespace="http://schemas.microsoft.com/office/2006/metadata/properties" ma:root="true" ma:fieldsID="e65e0207abcc1d0b9b22f7b2c8a99c98" ns3:_="" ns4:_="">
    <xsd:import namespace="6b1eb8ff-d135-439f-bb7f-2053783ee46f"/>
    <xsd:import namespace="5a9be704-24a8-48cf-a95f-6bbabe7e009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1eb8ff-d135-439f-bb7f-2053783ee46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9be704-24a8-48cf-a95f-6bbabe7e009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87CEA85-EE5A-4615-8104-3C2CE25D09E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9451E1D-0036-4A94-B2B5-14DE79E75D71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6b1eb8ff-d135-439f-bb7f-2053783ee46f"/>
    <ds:schemaRef ds:uri="http://schemas.microsoft.com/office/2006/documentManagement/types"/>
    <ds:schemaRef ds:uri="http://purl.org/dc/terms/"/>
    <ds:schemaRef ds:uri="5a9be704-24a8-48cf-a95f-6bbabe7e0097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30190CC1-BA59-4CAD-B093-6DDDCE9CE7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b1eb8ff-d135-439f-bb7f-2053783ee46f"/>
    <ds:schemaRef ds:uri="5a9be704-24a8-48cf-a95f-6bbabe7e009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67</TotalTime>
  <Words>104</Words>
  <Application>Microsoft Office PowerPoint</Application>
  <PresentationFormat>A4 Paper (210x297 mm)</PresentationFormat>
  <Paragraphs>12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unel University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er Kalef-Ezra (Staff)</dc:creator>
  <cp:lastModifiedBy>Sara Anjomani-Virmouni (Staff)</cp:lastModifiedBy>
  <cp:revision>164</cp:revision>
  <cp:lastPrinted>2020-02-12T13:06:24Z</cp:lastPrinted>
  <dcterms:created xsi:type="dcterms:W3CDTF">2020-02-06T15:12:20Z</dcterms:created>
  <dcterms:modified xsi:type="dcterms:W3CDTF">2022-07-30T10:02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0C26ED90A69A419BABE0D82A2EDDEE</vt:lpwstr>
  </property>
</Properties>
</file>